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0" d="100"/>
          <a:sy n="70" d="100"/>
        </p:scale>
        <p:origin x="-660" y="-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12B121-4CBF-485C-9D6C-95E64DAF275D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44F48C-837D-49B1-A2EB-753189D686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68946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12B121-4CBF-485C-9D6C-95E64DAF275D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44F48C-837D-49B1-A2EB-753189D686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39013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12B121-4CBF-485C-9D6C-95E64DAF275D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44F48C-837D-49B1-A2EB-753189D686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08347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12B121-4CBF-485C-9D6C-95E64DAF275D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44F48C-837D-49B1-A2EB-753189D686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50988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12B121-4CBF-485C-9D6C-95E64DAF275D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44F48C-837D-49B1-A2EB-753189D686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64759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12B121-4CBF-485C-9D6C-95E64DAF275D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44F48C-837D-49B1-A2EB-753189D686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48573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12B121-4CBF-485C-9D6C-95E64DAF275D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44F48C-837D-49B1-A2EB-753189D686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42172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12B121-4CBF-485C-9D6C-95E64DAF275D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44F48C-837D-49B1-A2EB-753189D686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47102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12B121-4CBF-485C-9D6C-95E64DAF275D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44F48C-837D-49B1-A2EB-753189D686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1289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12B121-4CBF-485C-9D6C-95E64DAF275D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44F48C-837D-49B1-A2EB-753189D686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25014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12B121-4CBF-485C-9D6C-95E64DAF275D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44F48C-837D-49B1-A2EB-753189D686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40986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12B121-4CBF-485C-9D6C-95E64DAF275D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44F48C-837D-49B1-A2EB-753189D686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65823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399245" y="243893"/>
            <a:ext cx="11397803" cy="6155796"/>
            <a:chOff x="399245" y="243893"/>
            <a:chExt cx="11397803" cy="6155796"/>
          </a:xfrm>
        </p:grpSpPr>
        <p:grpSp>
          <p:nvGrpSpPr>
            <p:cNvPr id="16" name="Group 15"/>
            <p:cNvGrpSpPr/>
            <p:nvPr/>
          </p:nvGrpSpPr>
          <p:grpSpPr>
            <a:xfrm>
              <a:off x="2228051" y="243893"/>
              <a:ext cx="7199290" cy="4891827"/>
              <a:chOff x="2009106" y="-52321"/>
              <a:chExt cx="7199290" cy="4891827"/>
            </a:xfrm>
          </p:grpSpPr>
          <p:pic>
            <p:nvPicPr>
              <p:cNvPr id="4" name="Picture 3"/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146" t="5079" r="7776" b="3497"/>
              <a:stretch/>
            </p:blipFill>
            <p:spPr>
              <a:xfrm>
                <a:off x="2009106" y="789905"/>
                <a:ext cx="7199290" cy="4049601"/>
              </a:xfrm>
              <a:prstGeom prst="rect">
                <a:avLst/>
              </a:prstGeom>
            </p:spPr>
          </p:pic>
          <p:sp>
            <p:nvSpPr>
              <p:cNvPr id="5" name="TextBox 4"/>
              <p:cNvSpPr txBox="1"/>
              <p:nvPr/>
            </p:nvSpPr>
            <p:spPr>
              <a:xfrm rot="18191587">
                <a:off x="2060622" y="232408"/>
                <a:ext cx="87576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ane 1</a:t>
                </a:r>
                <a:endPara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 rot="18191587">
                <a:off x="2650907" y="256018"/>
                <a:ext cx="87576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ane 2</a:t>
                </a:r>
                <a:endPara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 rot="18191587">
                <a:off x="3292702" y="240991"/>
                <a:ext cx="87576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ane 3</a:t>
                </a:r>
                <a:endPara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 rot="18191587">
                <a:off x="3882987" y="264601"/>
                <a:ext cx="87576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ane 4</a:t>
                </a:r>
                <a:endPara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 rot="18191587">
                <a:off x="4548355" y="253869"/>
                <a:ext cx="87576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ane 5</a:t>
                </a:r>
                <a:endPara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 rot="18191587">
                <a:off x="5138639" y="230258"/>
                <a:ext cx="87576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ane 6</a:t>
                </a:r>
                <a:endPara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 rot="18191587">
                <a:off x="5792224" y="216284"/>
                <a:ext cx="87576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ane 7</a:t>
                </a:r>
                <a:endPara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 rot="18191587">
                <a:off x="6418529" y="230258"/>
                <a:ext cx="87576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ane 8</a:t>
                </a:r>
                <a:endPara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 rot="18191587">
                <a:off x="7040075" y="253868"/>
                <a:ext cx="87576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ane 9</a:t>
                </a:r>
                <a:endPara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 rot="18191587">
                <a:off x="7614557" y="271045"/>
                <a:ext cx="87576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ane 10</a:t>
                </a:r>
                <a:endPara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 rot="18191587">
                <a:off x="8242413" y="253867"/>
                <a:ext cx="87576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ane 11</a:t>
                </a:r>
                <a:endPara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7" name="TextBox 16"/>
            <p:cNvSpPr txBox="1"/>
            <p:nvPr/>
          </p:nvSpPr>
          <p:spPr>
            <a:xfrm>
              <a:off x="399245" y="5537915"/>
              <a:ext cx="11397803" cy="8617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gure </a:t>
              </a:r>
              <a:r>
                <a:rPr lang="en-US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 </a:t>
              </a:r>
              <a:r>
                <a:rPr lang="en-US" sz="16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mplification of 470-bp </a:t>
              </a:r>
              <a:r>
                <a:rPr lang="en-US" sz="1600" i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ifH</a:t>
              </a:r>
              <a:r>
                <a:rPr lang="en-US" sz="16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gene fragment using the primers of F1-TAYGGIAARGGIGGIATYGGIAARTC </a:t>
              </a:r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d R6-TCIGGIGARATGATGGC </a:t>
              </a:r>
              <a:r>
                <a:rPr lang="en-US" sz="16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Lane 1 = ESK1, Lane 2 = ESK6, Lane 3 = ESK12, Lane 4 = ESK15, Lane 6 = ESK16, Lane 7 = 1 kb+ Ladder, Lane 8 = ESM2, Lane 9 = ESM4, Lane 10 = ESM5 and Lane 11 =  ESM7</a:t>
              </a:r>
              <a:endParaRPr 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9" name="Straight Arrow Connector 18"/>
            <p:cNvCxnSpPr/>
            <p:nvPr/>
          </p:nvCxnSpPr>
          <p:spPr>
            <a:xfrm flipH="1">
              <a:off x="9156885" y="3309870"/>
              <a:ext cx="450759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23" name="TextBox 22"/>
            <p:cNvSpPr txBox="1"/>
            <p:nvPr/>
          </p:nvSpPr>
          <p:spPr>
            <a:xfrm>
              <a:off x="9607644" y="3110919"/>
              <a:ext cx="115909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70-bp</a:t>
              </a:r>
              <a:endParaRPr 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8271910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93</Words>
  <Application>Microsoft Office PowerPoint</Application>
  <PresentationFormat>Custom</PresentationFormat>
  <Paragraphs>1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njurul</dc:creator>
  <cp:lastModifiedBy>Dr. Md. Manju</cp:lastModifiedBy>
  <cp:revision>6</cp:revision>
  <dcterms:created xsi:type="dcterms:W3CDTF">2021-07-02T05:09:13Z</dcterms:created>
  <dcterms:modified xsi:type="dcterms:W3CDTF">2021-10-03T08:15:13Z</dcterms:modified>
</cp:coreProperties>
</file>